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16"/>
    <p:restoredTop sz="96327"/>
  </p:normalViewPr>
  <p:slideViewPr>
    <p:cSldViewPr snapToGrid="0" snapToObjects="1">
      <p:cViewPr varScale="1">
        <p:scale>
          <a:sx n="110" d="100"/>
          <a:sy n="110" d="100"/>
        </p:scale>
        <p:origin x="11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9048E-7EA3-CD40-AF3F-98E64AA26C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56599E-0AFA-6741-BC88-B3200E6311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679EE-B2A8-564A-B837-1C501FF16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E6432-194B-1E4D-9F6A-35A9CF0F0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A98919-F31B-9E47-BEBA-A2F4C3774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184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48176-FD39-B24B-BBA9-1E25A7040C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419052-D0B1-3D43-A4F3-1AC5A8435D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F84964-A474-324B-9C8F-CED681AAE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60F7B7-069B-2E46-B2BD-2425BE7A0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458E6-DFCE-3A49-B6BF-E73F20B7C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71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FC9860-7C5D-A346-87E9-3D3E53A21F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E78889-F034-0640-AD04-E007DFFE0D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689C45-E727-294A-8D74-5C482C679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CA9DE2-683E-8E40-A2B5-FF9A96DEC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E64BB9-A3E6-514F-9C47-69BE91F0A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357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8988D-4EB8-724B-BEDD-27BE3AEC3F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00D937-8B2A-074F-8391-E0B9AAF124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E59031-DAFF-E24A-9487-796DBCB09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6FA14-ACF2-6846-849D-C531F04E8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17CA7-9308-C442-AF3D-CFF296FDE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97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FF4174-1270-A547-A497-AF34DACDE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F881ED-109E-C048-80AF-48866715F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312583-7E60-B341-8F46-9C99F82C4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3274AF-8968-C44A-A977-CB0841417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BBDC2A-82B4-C145-BBC6-48895E083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400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D9A959-269F-2441-B221-B360D403EA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9548E6-B347-CA49-94E6-44F36085C5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FB8904-ED37-DD47-B072-700E166AFD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0B91E5-CA45-2545-95B5-5DFDBDA26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AF2FF8-D885-0A47-9ED4-BAE89AE70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C2F0DB-07DA-F44F-B376-E97C463D2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021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27A8B0-B9AB-AA48-BDA3-3CFA3D3F4C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2AD6DA-737A-1B45-B6BC-79D358A6F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540150-AF4F-3C44-B51E-202E3552B7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96578F-48A7-7746-80CE-712FDBD252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552C00-00B9-304B-A3BE-7961CFD419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D53C3F-FA8B-6E4E-804A-2DBBAA0A1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1F3BD5-E004-9245-A161-9B74B2BBE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536C59-6086-F943-8DC2-B199AED35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759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A4FC4-A27B-174A-A0F7-6EAD6B293F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657DE9-BFCB-C449-8696-439372DA2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59C322-0BC7-244C-BC80-445C0A548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A865F4-B530-E649-8E0F-1C985D484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583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B4DCF6-3970-AD45-AE95-4BC2A6F7E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18DC25-D21E-EF4D-A99E-C60C11FB0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17AE06-D8D2-D843-AB4F-94AB5EE9D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547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8523C-B686-544C-BB12-F99D63197C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E030D2-D068-4649-B4C0-6A74F9E6AC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A62AD7-79FB-414A-B9F4-702270AF1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4FB929-9F9B-D542-9FD8-E180D8AC4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ED8766-94FC-ED44-A5CF-3ED1137E6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F50A63-279D-AC4C-8134-845F85CD0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086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A8890-9AFB-574A-AC7E-030492236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716757-6F71-BC43-AB52-D74A22C532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EDD4BF-DB5B-5140-A6B0-21B48280F0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E565A5-0C45-CE46-B17B-15FDF2501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597B22-AE6D-3247-B5C5-1CAF1CA03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665F95-FBC0-F644-9B51-610DF2B13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09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EA40C3-C10F-4147-81CC-1D04C9768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3E59ED-2E85-8540-8EB2-BD04D5B300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182A96-A5E0-CD4D-8643-8F8D53E2CF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D0BBF1-3AA8-8942-9E1D-498E4EB4ED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EAC3C-1750-F14E-850F-EE9E4DF34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04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Chart, scatter chart&#10;&#10;Description automatically generated">
            <a:extLst>
              <a:ext uri="{FF2B5EF4-FFF2-40B4-BE49-F238E27FC236}">
                <a16:creationId xmlns:a16="http://schemas.microsoft.com/office/drawing/2014/main" id="{4708E806-0159-8E41-ABF8-8B8ABB1EC6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776" y="483189"/>
            <a:ext cx="5247595" cy="2115966"/>
          </a:xfrm>
          <a:prstGeom prst="rect">
            <a:avLst/>
          </a:prstGeom>
        </p:spPr>
      </p:pic>
      <p:pic>
        <p:nvPicPr>
          <p:cNvPr id="23" name="Picture 22" descr="Chart, scatter chart&#10;&#10;Description automatically generated">
            <a:extLst>
              <a:ext uri="{FF2B5EF4-FFF2-40B4-BE49-F238E27FC236}">
                <a16:creationId xmlns:a16="http://schemas.microsoft.com/office/drawing/2014/main" id="{4494843B-AEE4-DA49-8380-8D3667E47006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302148" y="483189"/>
            <a:ext cx="5247595" cy="2099467"/>
          </a:xfrm>
          <a:prstGeom prst="rect">
            <a:avLst/>
          </a:prstGeom>
        </p:spPr>
      </p:pic>
      <p:pic>
        <p:nvPicPr>
          <p:cNvPr id="25" name="Picture 24" descr="Chart&#10;&#10;Description automatically generated">
            <a:extLst>
              <a:ext uri="{FF2B5EF4-FFF2-40B4-BE49-F238E27FC236}">
                <a16:creationId xmlns:a16="http://schemas.microsoft.com/office/drawing/2014/main" id="{8BCFF50D-831A-644A-8455-255D52BFD030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97776" y="3180104"/>
            <a:ext cx="5247595" cy="2099467"/>
          </a:xfrm>
          <a:prstGeom prst="rect">
            <a:avLst/>
          </a:prstGeom>
        </p:spPr>
      </p:pic>
      <p:pic>
        <p:nvPicPr>
          <p:cNvPr id="27" name="Picture 26" descr="Chart, scatter chart&#10;&#10;Description automatically generated">
            <a:extLst>
              <a:ext uri="{FF2B5EF4-FFF2-40B4-BE49-F238E27FC236}">
                <a16:creationId xmlns:a16="http://schemas.microsoft.com/office/drawing/2014/main" id="{92678A49-23D3-1A4C-AFC0-1E9AF243BAD0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302148" y="3180104"/>
            <a:ext cx="5247595" cy="2099467"/>
          </a:xfrm>
          <a:prstGeom prst="rect">
            <a:avLst/>
          </a:prstGeom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8996523B-6973-9F4E-A0F4-87488C75BB7A}"/>
              </a:ext>
            </a:extLst>
          </p:cNvPr>
          <p:cNvSpPr/>
          <p:nvPr/>
        </p:nvSpPr>
        <p:spPr>
          <a:xfrm>
            <a:off x="197776" y="237940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G" sz="1159" b="1" dirty="0"/>
              <a:t>t0</a:t>
            </a:r>
            <a:endParaRPr lang="en-BG" sz="1159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7D2FCFC-5385-3F41-A5D2-A63CE425B48F}"/>
              </a:ext>
            </a:extLst>
          </p:cNvPr>
          <p:cNvSpPr/>
          <p:nvPr/>
        </p:nvSpPr>
        <p:spPr>
          <a:xfrm>
            <a:off x="6302148" y="237940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G" sz="1159" b="1" dirty="0"/>
              <a:t>t12</a:t>
            </a:r>
            <a:endParaRPr lang="en-BG" sz="1159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3E6EE1D-8182-A84C-A216-691A005F9930}"/>
              </a:ext>
            </a:extLst>
          </p:cNvPr>
          <p:cNvSpPr/>
          <p:nvPr/>
        </p:nvSpPr>
        <p:spPr>
          <a:xfrm>
            <a:off x="197776" y="2955282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9" b="1" dirty="0"/>
              <a:t>t</a:t>
            </a:r>
            <a:r>
              <a:rPr lang="en-BG" sz="1159" b="1" dirty="0"/>
              <a:t>48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CE25931A-E707-1B49-947A-A8924128003A}"/>
              </a:ext>
            </a:extLst>
          </p:cNvPr>
          <p:cNvSpPr/>
          <p:nvPr/>
        </p:nvSpPr>
        <p:spPr>
          <a:xfrm>
            <a:off x="6324946" y="2855621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9" b="1" dirty="0"/>
              <a:t>t</a:t>
            </a:r>
            <a:r>
              <a:rPr lang="en-BG" sz="1159" b="1" dirty="0"/>
              <a:t>9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563D9BC-9CC6-7248-913E-B1234A62A256}"/>
              </a:ext>
            </a:extLst>
          </p:cNvPr>
          <p:cNvSpPr txBox="1"/>
          <p:nvPr/>
        </p:nvSpPr>
        <p:spPr>
          <a:xfrm>
            <a:off x="169003" y="5911878"/>
            <a:ext cx="118539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b="1">
                <a:latin typeface="Arial Narrow" panose="020B0604020202020204" pitchFamily="34" charset="0"/>
                <a:cs typeface="Arial Narrow" panose="020B0604020202020204" pitchFamily="34" charset="0"/>
              </a:rPr>
              <a:t>Supplementary Figure </a:t>
            </a:r>
            <a:r>
              <a:rPr lang="en-US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1</a:t>
            </a:r>
            <a:r>
              <a:rPr lang="en-BG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. </a:t>
            </a:r>
            <a:r>
              <a:rPr lang="en-US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Density plots showing the distribution of cells based on proportion of transcripts of mitochondrial origin (left), and number of genes (right) plotted against the counts of sequencing reads in the 4 time-</a:t>
            </a:r>
            <a:r>
              <a:rPr lang="en-US" sz="14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ponts</a:t>
            </a:r>
            <a:r>
              <a:rPr lang="en-US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 after MCF7 drug treatment. The dotted line indicates the selected QC thresholds: mitochondrial gene expression above between 7.5 and 15%, and number of genes below 1000 or above between 4500 and 5500. 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28B45D5-AD44-7341-A9B9-96A818CE43A5}"/>
              </a:ext>
            </a:extLst>
          </p:cNvPr>
          <p:cNvCxnSpPr/>
          <p:nvPr/>
        </p:nvCxnSpPr>
        <p:spPr>
          <a:xfrm>
            <a:off x="405925" y="1807436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2F07B37-81B1-C64F-9FFD-7A1EF3F3D78A}"/>
              </a:ext>
            </a:extLst>
          </p:cNvPr>
          <p:cNvCxnSpPr/>
          <p:nvPr/>
        </p:nvCxnSpPr>
        <p:spPr>
          <a:xfrm>
            <a:off x="3028060" y="831791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767F035-C06F-4249-9DE7-D51854F40E39}"/>
              </a:ext>
            </a:extLst>
          </p:cNvPr>
          <p:cNvCxnSpPr>
            <a:cxnSpLocks/>
          </p:cNvCxnSpPr>
          <p:nvPr/>
        </p:nvCxnSpPr>
        <p:spPr>
          <a:xfrm>
            <a:off x="1648224" y="620295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032D00A-D35D-3F44-85D2-F6B191B9DF6F}"/>
              </a:ext>
            </a:extLst>
          </p:cNvPr>
          <p:cNvCxnSpPr>
            <a:cxnSpLocks/>
          </p:cNvCxnSpPr>
          <p:nvPr/>
        </p:nvCxnSpPr>
        <p:spPr>
          <a:xfrm>
            <a:off x="4278914" y="660125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E92A35FD-80AB-D343-9E50-305886DFE967}"/>
              </a:ext>
            </a:extLst>
          </p:cNvPr>
          <p:cNvCxnSpPr/>
          <p:nvPr/>
        </p:nvCxnSpPr>
        <p:spPr>
          <a:xfrm>
            <a:off x="3028060" y="2315686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D8C5DC4-8C5D-CA47-83A0-D91EC8170A46}"/>
              </a:ext>
            </a:extLst>
          </p:cNvPr>
          <p:cNvCxnSpPr/>
          <p:nvPr/>
        </p:nvCxnSpPr>
        <p:spPr>
          <a:xfrm>
            <a:off x="411272" y="4467748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B8426B4C-DD14-9E43-B6BB-0583C5A3EEC2}"/>
              </a:ext>
            </a:extLst>
          </p:cNvPr>
          <p:cNvCxnSpPr/>
          <p:nvPr/>
        </p:nvCxnSpPr>
        <p:spPr>
          <a:xfrm>
            <a:off x="3028060" y="3524191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65EAB337-D7F9-7945-B236-A2903BF5CF2E}"/>
              </a:ext>
            </a:extLst>
          </p:cNvPr>
          <p:cNvCxnSpPr>
            <a:cxnSpLocks/>
          </p:cNvCxnSpPr>
          <p:nvPr/>
        </p:nvCxnSpPr>
        <p:spPr>
          <a:xfrm>
            <a:off x="1843399" y="3323391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ACBA7F7-9BAA-FD4B-8DFE-AADF67DF90C6}"/>
              </a:ext>
            </a:extLst>
          </p:cNvPr>
          <p:cNvCxnSpPr>
            <a:cxnSpLocks/>
          </p:cNvCxnSpPr>
          <p:nvPr/>
        </p:nvCxnSpPr>
        <p:spPr>
          <a:xfrm>
            <a:off x="4463395" y="3320445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DEEA4BB7-A407-444F-B60E-F9A7AB381987}"/>
              </a:ext>
            </a:extLst>
          </p:cNvPr>
          <p:cNvCxnSpPr/>
          <p:nvPr/>
        </p:nvCxnSpPr>
        <p:spPr>
          <a:xfrm>
            <a:off x="3028060" y="4997391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D939E959-9E6C-374E-8B47-59F65C649247}"/>
              </a:ext>
            </a:extLst>
          </p:cNvPr>
          <p:cNvCxnSpPr/>
          <p:nvPr/>
        </p:nvCxnSpPr>
        <p:spPr>
          <a:xfrm>
            <a:off x="6513622" y="4577167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E50C52F4-0025-D047-8C48-029C55E2DACF}"/>
              </a:ext>
            </a:extLst>
          </p:cNvPr>
          <p:cNvCxnSpPr/>
          <p:nvPr/>
        </p:nvCxnSpPr>
        <p:spPr>
          <a:xfrm>
            <a:off x="9130410" y="3633610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413E9F2-6732-E04B-BEE0-17B4CF797848}"/>
              </a:ext>
            </a:extLst>
          </p:cNvPr>
          <p:cNvCxnSpPr>
            <a:cxnSpLocks/>
          </p:cNvCxnSpPr>
          <p:nvPr/>
        </p:nvCxnSpPr>
        <p:spPr>
          <a:xfrm>
            <a:off x="7667619" y="3333750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5AF0A036-002A-A64A-B83C-7EA9859E6096}"/>
              </a:ext>
            </a:extLst>
          </p:cNvPr>
          <p:cNvCxnSpPr>
            <a:cxnSpLocks/>
          </p:cNvCxnSpPr>
          <p:nvPr/>
        </p:nvCxnSpPr>
        <p:spPr>
          <a:xfrm>
            <a:off x="10283805" y="3333750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9E59F5B0-024E-5C41-ADA9-48A833447EA2}"/>
              </a:ext>
            </a:extLst>
          </p:cNvPr>
          <p:cNvCxnSpPr/>
          <p:nvPr/>
        </p:nvCxnSpPr>
        <p:spPr>
          <a:xfrm>
            <a:off x="9130410" y="4968321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F5FC57B6-BF15-2E4E-9C38-5A365B264A07}"/>
              </a:ext>
            </a:extLst>
          </p:cNvPr>
          <p:cNvCxnSpPr/>
          <p:nvPr/>
        </p:nvCxnSpPr>
        <p:spPr>
          <a:xfrm>
            <a:off x="6517816" y="1867906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D0B36A99-A893-5E49-B314-735163A9E119}"/>
              </a:ext>
            </a:extLst>
          </p:cNvPr>
          <p:cNvCxnSpPr/>
          <p:nvPr/>
        </p:nvCxnSpPr>
        <p:spPr>
          <a:xfrm>
            <a:off x="9130410" y="1150853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8DE5667C-5A9A-5947-8568-6693124F516E}"/>
              </a:ext>
            </a:extLst>
          </p:cNvPr>
          <p:cNvCxnSpPr>
            <a:cxnSpLocks/>
          </p:cNvCxnSpPr>
          <p:nvPr/>
        </p:nvCxnSpPr>
        <p:spPr>
          <a:xfrm>
            <a:off x="7613096" y="632877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A4E2FF0-498A-DA4F-98EE-48561EAC7C7A}"/>
              </a:ext>
            </a:extLst>
          </p:cNvPr>
          <p:cNvCxnSpPr>
            <a:cxnSpLocks/>
          </p:cNvCxnSpPr>
          <p:nvPr/>
        </p:nvCxnSpPr>
        <p:spPr>
          <a:xfrm>
            <a:off x="10233476" y="628683"/>
            <a:ext cx="0" cy="1771815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2FF946C-FF34-1D45-9AC0-FC06B6E89688}"/>
              </a:ext>
            </a:extLst>
          </p:cNvPr>
          <p:cNvCxnSpPr/>
          <p:nvPr/>
        </p:nvCxnSpPr>
        <p:spPr>
          <a:xfrm>
            <a:off x="9130410" y="2301000"/>
            <a:ext cx="1811709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5384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82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rvath, Anelia Dafinova</dc:creator>
  <cp:lastModifiedBy>Horvath, Anelia Dafinova</cp:lastModifiedBy>
  <cp:revision>8</cp:revision>
  <dcterms:created xsi:type="dcterms:W3CDTF">2021-06-11T17:52:30Z</dcterms:created>
  <dcterms:modified xsi:type="dcterms:W3CDTF">2021-09-26T13:20:46Z</dcterms:modified>
</cp:coreProperties>
</file>